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66" r:id="rId3"/>
    <p:sldId id="272" r:id="rId4"/>
    <p:sldId id="278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DEBFB"/>
    <a:srgbClr val="E1646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14"/>
    <p:restoredTop sz="94586"/>
  </p:normalViewPr>
  <p:slideViewPr>
    <p:cSldViewPr snapToGrid="0" snapToObjects="1">
      <p:cViewPr varScale="1">
        <p:scale>
          <a:sx n="78" d="100"/>
          <a:sy n="78" d="100"/>
        </p:scale>
        <p:origin x="19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8479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4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24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07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553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819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703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082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544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739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754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BDEFEA-22A2-0446-B1F7-23F2AF95D145}" type="datetimeFigureOut">
              <a:rPr lang="en-US" smtClean="0"/>
              <a:t>4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02731-062F-C64A-9EC0-B579D8379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11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45ACEA5A-59AA-9C43-9EB4-ECF956F32A14}"/>
              </a:ext>
            </a:extLst>
          </p:cNvPr>
          <p:cNvSpPr txBox="1"/>
          <p:nvPr/>
        </p:nvSpPr>
        <p:spPr>
          <a:xfrm>
            <a:off x="2677887" y="7935686"/>
            <a:ext cx="1314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. Fig. 1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7CE22C6-DB3A-B947-8B6E-2C7FD3367A4A}"/>
              </a:ext>
            </a:extLst>
          </p:cNvPr>
          <p:cNvSpPr/>
          <p:nvPr/>
        </p:nvSpPr>
        <p:spPr>
          <a:xfrm>
            <a:off x="342902" y="5685459"/>
            <a:ext cx="5992584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1. Size distribution of mapped reads in the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iboseq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NAseq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nalyses.  Mean cDNA sequence length was 32-34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p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with a shoulder at ~30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p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for the ribosome-protected fragments (RPFs) and about 31bp for the fragmented cDNAs in the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NAseq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nalysis.</a:t>
            </a:r>
            <a:endParaRPr lang="en-US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2C7A05C-FDCB-AD4E-B897-98914BAFB9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0915" y="2824842"/>
            <a:ext cx="5918200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4127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D83CCA3-200E-CB4E-A2DD-2A1A22215769}"/>
              </a:ext>
            </a:extLst>
          </p:cNvPr>
          <p:cNvSpPr txBox="1"/>
          <p:nvPr/>
        </p:nvSpPr>
        <p:spPr>
          <a:xfrm>
            <a:off x="1219200" y="5472545"/>
            <a:ext cx="563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earson correlation coefficients between replicate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36A64C6-29E4-0048-8569-524AB00E3933}"/>
              </a:ext>
            </a:extLst>
          </p:cNvPr>
          <p:cNvSpPr txBox="1"/>
          <p:nvPr/>
        </p:nvSpPr>
        <p:spPr>
          <a:xfrm>
            <a:off x="2913415" y="8379032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. Fig.2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0728141-10CA-6645-B674-9FF92D39A6A0}"/>
              </a:ext>
            </a:extLst>
          </p:cNvPr>
          <p:cNvSpPr/>
          <p:nvPr/>
        </p:nvSpPr>
        <p:spPr>
          <a:xfrm>
            <a:off x="473527" y="6745055"/>
            <a:ext cx="5976257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2. Pearson correlation coefficients between replicates.  Duplicate samples at the three timepoints for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iboseq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NAseq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nalyses were compared.</a:t>
            </a:r>
            <a:endParaRPr lang="en-US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8CD323B-4C44-C040-8D4A-BE09C9CE79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971800"/>
            <a:ext cx="6858000" cy="320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06148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08F2EF7-5B5B-7C45-9D7F-B21435ED0CB5}"/>
              </a:ext>
            </a:extLst>
          </p:cNvPr>
          <p:cNvGrpSpPr/>
          <p:nvPr/>
        </p:nvGrpSpPr>
        <p:grpSpPr>
          <a:xfrm>
            <a:off x="2240710" y="2323560"/>
            <a:ext cx="1880040" cy="2071627"/>
            <a:chOff x="904142" y="5181654"/>
            <a:chExt cx="1880040" cy="207162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F7B00A3-6A14-294F-8318-AAF1C330B07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42000" contras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04142" y="5181654"/>
              <a:ext cx="1880040" cy="66361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9F85F36-F44A-A546-97D1-2E0EEC673E7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04142" y="5918456"/>
              <a:ext cx="1870441" cy="65339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CF627ED-36A1-5A4E-9547-62D38CEB274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flipH="1">
              <a:off x="904142" y="6654983"/>
              <a:ext cx="1880040" cy="598298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3EE001AC-5EF8-7A42-B9A1-5BAAC8B2E761}"/>
              </a:ext>
            </a:extLst>
          </p:cNvPr>
          <p:cNvSpPr txBox="1"/>
          <p:nvPr/>
        </p:nvSpPr>
        <p:spPr>
          <a:xfrm>
            <a:off x="1819896" y="4422782"/>
            <a:ext cx="27239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</a:t>
            </a:r>
            <a:r>
              <a:rPr lang="en-US" dirty="0">
                <a:cs typeface="Arial" panose="020B0604020202020204" pitchFamily="34" charset="0"/>
              </a:rPr>
              <a:t>Untreated     TM (6h)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A986A2E-1B67-B74A-B9C5-A19648D5540A}"/>
              </a:ext>
            </a:extLst>
          </p:cNvPr>
          <p:cNvSpPr txBox="1"/>
          <p:nvPr/>
        </p:nvSpPr>
        <p:spPr>
          <a:xfrm>
            <a:off x="4130630" y="2447037"/>
            <a:ext cx="1262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cs typeface="Arial" panose="020B0604020202020204" pitchFamily="34" charset="0"/>
              </a:rPr>
              <a:t>bZIP60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C63F003-2C59-634C-AAFB-9D23FB998EA5}"/>
              </a:ext>
            </a:extLst>
          </p:cNvPr>
          <p:cNvSpPr txBox="1"/>
          <p:nvPr/>
        </p:nvSpPr>
        <p:spPr>
          <a:xfrm>
            <a:off x="4149203" y="3148431"/>
            <a:ext cx="1475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cs typeface="Arial" panose="020B0604020202020204" pitchFamily="34" charset="0"/>
              </a:rPr>
              <a:t>BIP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56085F3-4B67-214D-B094-599EA4D7B441}"/>
              </a:ext>
            </a:extLst>
          </p:cNvPr>
          <p:cNvSpPr txBox="1"/>
          <p:nvPr/>
        </p:nvSpPr>
        <p:spPr>
          <a:xfrm>
            <a:off x="4163354" y="3861446"/>
            <a:ext cx="1475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cs typeface="Arial" panose="020B0604020202020204" pitchFamily="34" charset="0"/>
              </a:rPr>
              <a:t>CNX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F089031-D52F-294E-A5D6-38236CBABB4E}"/>
              </a:ext>
            </a:extLst>
          </p:cNvPr>
          <p:cNvSpPr txBox="1"/>
          <p:nvPr/>
        </p:nvSpPr>
        <p:spPr>
          <a:xfrm>
            <a:off x="2608614" y="7894122"/>
            <a:ext cx="1314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. Fig. 3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1DEC93DE-4AB3-E64A-B5CE-7286BB5C9B4F}"/>
              </a:ext>
            </a:extLst>
          </p:cNvPr>
          <p:cNvSpPr/>
          <p:nvPr/>
        </p:nvSpPr>
        <p:spPr>
          <a:xfrm>
            <a:off x="734786" y="5569399"/>
            <a:ext cx="555171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4. UPR canonical gene expression in maize leaf protoplasts as analyzed by RT-PCR in untreated versus 6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r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TM-treated protoplasts.  </a:t>
            </a:r>
            <a:endParaRPr lang="en-US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29318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2B162B2F-244C-114B-B228-2F5C0BC649E0}"/>
              </a:ext>
            </a:extLst>
          </p:cNvPr>
          <p:cNvSpPr/>
          <p:nvPr/>
        </p:nvSpPr>
        <p:spPr>
          <a:xfrm>
            <a:off x="675860" y="1299612"/>
            <a:ext cx="5751444" cy="50544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dirty="0">
                <a:latin typeface="Courier" pitchFamily="2" charset="0"/>
                <a:ea typeface="Times New Roman" panose="02020603050405020304" pitchFamily="18" charset="0"/>
              </a:rPr>
              <a:t>Table S1</a:t>
            </a:r>
          </a:p>
          <a:p>
            <a:pPr>
              <a:lnSpc>
                <a:spcPct val="150000"/>
              </a:lnSpc>
            </a:pPr>
            <a:r>
              <a:rPr lang="en-US" sz="1200" b="1" dirty="0">
                <a:latin typeface="Courier" pitchFamily="2" charset="0"/>
                <a:ea typeface="Times New Roman" panose="02020603050405020304" pitchFamily="18" charset="0"/>
              </a:rPr>
              <a:t>Sequence of primers used: in RT-qPCR: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BIP2 F: GTCGGAGAAGATCACGATCAC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BIP2 R: CTTCACCTTCTTGTCCTCCTC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PDI 1-1 F:  GTCGCTTGGTTGAAGGAGTA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PDI 1-1R: CACCTTAACAGGCTCATTGTTG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PDI 2-3 F: GCAAGTACAAGGTGGAAGG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PDI 2-3 R: CCAACTGCTCCAATGCAAAG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Der F: TGGTGCCATCTCACTATTGG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Der R: CTCTCGGCTCCAGACAT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ERD F: GGCCCGTCTCTTCATCTATTC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ERD R:  TACCCGTTTGGAGAATCTTGG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Tub F: CTACACCATTGGCAAGGAGAT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Tub-R: CCTGGAGACCAGTGCAATTAT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 err="1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Ubi</a:t>
            </a: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 F: ATCTTCGTGAAGACGCTGAC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fontAlgn="base">
              <a:lnSpc>
                <a:spcPct val="150000"/>
              </a:lnSpc>
            </a:pPr>
            <a:r>
              <a:rPr lang="en-US" sz="1200" dirty="0" err="1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Ubi</a:t>
            </a:r>
            <a:r>
              <a:rPr lang="en-US" sz="1200" dirty="0">
                <a:solidFill>
                  <a:srgbClr val="000000"/>
                </a:solidFill>
                <a:latin typeface="Courier" pitchFamily="2" charset="0"/>
                <a:ea typeface="Times New Roman" panose="02020603050405020304" pitchFamily="18" charset="0"/>
              </a:rPr>
              <a:t> R: GATGCCTTCCTTGTCCTGTATC</a:t>
            </a:r>
            <a:endParaRPr lang="en-US" sz="1200" dirty="0">
              <a:latin typeface="Courier" pitchFamily="2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Courier" pitchFamily="2" charset="0"/>
                <a:ea typeface="Times New Roman" panose="02020603050405020304" pitchFamily="18" charset="0"/>
              </a:rPr>
              <a:t>PAB2FpAsc:     </a:t>
            </a:r>
            <a:r>
              <a:rPr lang="en-US" sz="1200" dirty="0" err="1">
                <a:latin typeface="Courier" pitchFamily="2" charset="0"/>
                <a:ea typeface="Times New Roman" panose="02020603050405020304" pitchFamily="18" charset="0"/>
              </a:rPr>
              <a:t>gaaggcgcgccATGGCGACGCAAGGGCAAGC</a:t>
            </a:r>
            <a:r>
              <a:rPr lang="en-US" sz="1200" dirty="0">
                <a:latin typeface="Courier" pitchFamily="2" charset="0"/>
                <a:ea typeface="Times New Roman" panose="02020603050405020304" pitchFamily="18" charset="0"/>
              </a:rPr>
              <a:t>   ( 5’-3’)</a:t>
            </a: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Courier" pitchFamily="2" charset="0"/>
                <a:ea typeface="Times New Roman" panose="02020603050405020304" pitchFamily="18" charset="0"/>
              </a:rPr>
              <a:t>PAB2RpXba:     </a:t>
            </a:r>
            <a:r>
              <a:rPr lang="en-US" sz="1200" dirty="0" err="1">
                <a:latin typeface="Courier" pitchFamily="2" charset="0"/>
                <a:ea typeface="Times New Roman" panose="02020603050405020304" pitchFamily="18" charset="0"/>
              </a:rPr>
              <a:t>agtctagaGCTGGAGACGACGCCATCATT</a:t>
            </a:r>
            <a:r>
              <a:rPr lang="en-US" sz="1200" dirty="0">
                <a:latin typeface="Courier" pitchFamily="2" charset="0"/>
                <a:ea typeface="Times New Roman" panose="02020603050405020304" pitchFamily="18" charset="0"/>
              </a:rPr>
              <a:t>  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7CFAFB5-7C85-8045-9F67-842A8A094465}"/>
              </a:ext>
            </a:extLst>
          </p:cNvPr>
          <p:cNvSpPr txBox="1"/>
          <p:nvPr/>
        </p:nvSpPr>
        <p:spPr>
          <a:xfrm>
            <a:off x="2608614" y="7894122"/>
            <a:ext cx="1484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. Table 1</a:t>
            </a:r>
          </a:p>
        </p:txBody>
      </p:sp>
    </p:spTree>
    <p:extLst>
      <p:ext uri="{BB962C8B-B14F-4D97-AF65-F5344CB8AC3E}">
        <p14:creationId xmlns:p14="http://schemas.microsoft.com/office/powerpoint/2010/main" val="1200135849"/>
      </p:ext>
    </p:extLst>
  </p:cSld>
  <p:clrMapOvr>
    <a:masterClrMapping/>
  </p:clrMapOvr>
</p:sld>
</file>

<file path=ppt/theme/theme1.xml><?xml version="1.0" encoding="utf-8"?>
<a:theme xmlns:a="http://schemas.openxmlformats.org/drawingml/2006/main" name="squar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square" id="{77564E27-5924-0E45-93DE-9E45F60ADBB4}" vid="{F4576588-96D2-F049-9404-838EE9F956C1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square</Template>
  <TotalTime>109736</TotalTime>
  <Words>220</Words>
  <Application>Microsoft Macintosh PowerPoint</Application>
  <PresentationFormat>Letter Paper (8.5x11 in)</PresentationFormat>
  <Paragraphs>3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Courier</vt:lpstr>
      <vt:lpstr>Times New Roman</vt:lpstr>
      <vt:lpstr>squar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well, Stephen H [PSI]</dc:creator>
  <cp:lastModifiedBy>Howell, Stephen H [PSI]</cp:lastModifiedBy>
  <cp:revision>165</cp:revision>
  <dcterms:created xsi:type="dcterms:W3CDTF">2018-10-09T20:07:38Z</dcterms:created>
  <dcterms:modified xsi:type="dcterms:W3CDTF">2020-04-16T02:18:50Z</dcterms:modified>
</cp:coreProperties>
</file>